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  <p:sldId id="259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78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na Dusch" userId="bf2fb21b29b406ee" providerId="LiveId" clId="{0416E3F9-6FB5-4914-85F8-F0150639AB81}"/>
    <pc:docChg chg="modSld">
      <pc:chgData name="Alena Dusch" userId="bf2fb21b29b406ee" providerId="LiveId" clId="{0416E3F9-6FB5-4914-85F8-F0150639AB81}" dt="2026-07-10T20:20:20.814" v="40" actId="20577"/>
      <pc:docMkLst>
        <pc:docMk/>
      </pc:docMkLst>
      <pc:sldChg chg="modSp mod">
        <pc:chgData name="Alena Dusch" userId="bf2fb21b29b406ee" providerId="LiveId" clId="{0416E3F9-6FB5-4914-85F8-F0150639AB81}" dt="2026-06-30T20:53:04.115" v="26" actId="1076"/>
        <pc:sldMkLst>
          <pc:docMk/>
          <pc:sldMk cId="599519249" sldId="256"/>
        </pc:sldMkLst>
        <pc:spChg chg="mod">
          <ac:chgData name="Alena Dusch" userId="bf2fb21b29b406ee" providerId="LiveId" clId="{0416E3F9-6FB5-4914-85F8-F0150639AB81}" dt="2026-06-30T20:53:04.115" v="26" actId="1076"/>
          <ac:spMkLst>
            <pc:docMk/>
            <pc:sldMk cId="599519249" sldId="256"/>
            <ac:spMk id="5" creationId="{9F65D90C-D162-4DF7-83F7-9C46D41BC11D}"/>
          </ac:spMkLst>
        </pc:spChg>
      </pc:sldChg>
      <pc:sldChg chg="modSp mod">
        <pc:chgData name="Alena Dusch" userId="bf2fb21b29b406ee" providerId="LiveId" clId="{0416E3F9-6FB5-4914-85F8-F0150639AB81}" dt="2026-06-30T20:52:51.333" v="13" actId="1076"/>
        <pc:sldMkLst>
          <pc:docMk/>
          <pc:sldMk cId="220269584" sldId="258"/>
        </pc:sldMkLst>
        <pc:spChg chg="mod">
          <ac:chgData name="Alena Dusch" userId="bf2fb21b29b406ee" providerId="LiveId" clId="{0416E3F9-6FB5-4914-85F8-F0150639AB81}" dt="2026-06-30T20:52:51.333" v="13" actId="1076"/>
          <ac:spMkLst>
            <pc:docMk/>
            <pc:sldMk cId="220269584" sldId="258"/>
            <ac:spMk id="3" creationId="{F9DC7F46-5DFB-4409-AF01-4791C25D2FF1}"/>
          </ac:spMkLst>
        </pc:spChg>
      </pc:sldChg>
      <pc:sldChg chg="modSp mod">
        <pc:chgData name="Alena Dusch" userId="bf2fb21b29b406ee" providerId="LiveId" clId="{0416E3F9-6FB5-4914-85F8-F0150639AB81}" dt="2026-07-10T20:20:20.814" v="40" actId="20577"/>
        <pc:sldMkLst>
          <pc:docMk/>
          <pc:sldMk cId="745951065" sldId="259"/>
        </pc:sldMkLst>
        <pc:spChg chg="mod">
          <ac:chgData name="Alena Dusch" userId="bf2fb21b29b406ee" providerId="LiveId" clId="{0416E3F9-6FB5-4914-85F8-F0150639AB81}" dt="2026-07-10T20:20:20.814" v="40" actId="20577"/>
          <ac:spMkLst>
            <pc:docMk/>
            <pc:sldMk cId="745951065" sldId="259"/>
            <ac:spMk id="4" creationId="{63E584CA-045F-7E08-A105-81FCFF4F8DCA}"/>
          </ac:spMkLst>
        </pc:spChg>
      </pc:sldChg>
    </pc:docChg>
  </pc:docChgLst>
  <pc:docChgLst>
    <pc:chgData name="Alena Dusch" userId="bf2fb21b29b406ee" providerId="LiveId" clId="{BFE2ADB8-01B8-4E68-8BFC-FD6C7086E29C}"/>
    <pc:docChg chg="undo custSel addSld modSld">
      <pc:chgData name="Alena Dusch" userId="bf2fb21b29b406ee" providerId="LiveId" clId="{BFE2ADB8-01B8-4E68-8BFC-FD6C7086E29C}" dt="2026-06-25T14:55:05.488" v="290"/>
      <pc:docMkLst>
        <pc:docMk/>
      </pc:docMkLst>
      <pc:sldChg chg="addSp delSp modSp new mod">
        <pc:chgData name="Alena Dusch" userId="bf2fb21b29b406ee" providerId="LiveId" clId="{BFE2ADB8-01B8-4E68-8BFC-FD6C7086E29C}" dt="2026-06-25T14:55:05.488" v="290"/>
        <pc:sldMkLst>
          <pc:docMk/>
          <pc:sldMk cId="745951065" sldId="259"/>
        </pc:sldMkLst>
        <pc:spChg chg="del">
          <ac:chgData name="Alena Dusch" userId="bf2fb21b29b406ee" providerId="LiveId" clId="{BFE2ADB8-01B8-4E68-8BFC-FD6C7086E29C}" dt="2026-06-25T14:36:03.715" v="55" actId="478"/>
          <ac:spMkLst>
            <pc:docMk/>
            <pc:sldMk cId="745951065" sldId="259"/>
            <ac:spMk id="2" creationId="{C8F382BF-D349-ACFC-CB11-0A16312CBC49}"/>
          </ac:spMkLst>
        </pc:spChg>
        <pc:spChg chg="del">
          <ac:chgData name="Alena Dusch" userId="bf2fb21b29b406ee" providerId="LiveId" clId="{BFE2ADB8-01B8-4E68-8BFC-FD6C7086E29C}" dt="2026-06-25T14:36:01.924" v="54" actId="478"/>
          <ac:spMkLst>
            <pc:docMk/>
            <pc:sldMk cId="745951065" sldId="259"/>
            <ac:spMk id="3" creationId="{E9A8BA94-D886-47EA-D5F9-261DFAD418E6}"/>
          </ac:spMkLst>
        </pc:spChg>
        <pc:spChg chg="add mod">
          <ac:chgData name="Alena Dusch" userId="bf2fb21b29b406ee" providerId="LiveId" clId="{BFE2ADB8-01B8-4E68-8BFC-FD6C7086E29C}" dt="2026-06-25T14:50:29.971" v="241" actId="1076"/>
          <ac:spMkLst>
            <pc:docMk/>
            <pc:sldMk cId="745951065" sldId="259"/>
            <ac:spMk id="4" creationId="{63E584CA-045F-7E08-A105-81FCFF4F8DCA}"/>
          </ac:spMkLst>
        </pc:spChg>
        <pc:graphicFrameChg chg="add mod modGraphic">
          <ac:chgData name="Alena Dusch" userId="bf2fb21b29b406ee" providerId="LiveId" clId="{BFE2ADB8-01B8-4E68-8BFC-FD6C7086E29C}" dt="2026-06-25T14:55:05.488" v="290"/>
          <ac:graphicFrameMkLst>
            <pc:docMk/>
            <pc:sldMk cId="745951065" sldId="259"/>
            <ac:graphicFrameMk id="5" creationId="{A01559CE-B508-4931-45F1-9EE34164E463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95D8682-2BD2-44FC-8B5C-29D629351F4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2749E2F7-486A-4EFA-B34B-214B9300D0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8C694F8-1E04-4E78-81D4-063F9A1A4C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408C7-6A37-47A3-9FD4-AA32AA6DBD31}" type="datetimeFigureOut">
              <a:rPr lang="de-DE" smtClean="0"/>
              <a:t>10.07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6C138D5-0D82-48C9-80D2-9AC2A1F0E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ABFD842-87FA-457E-8763-13C0307DC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530-2643-4568-8089-08904E70F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0261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F0021EB-9736-4418-A5E0-CA1EDC4736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528C728-4000-4995-B1F0-EEAE5FC7DB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5AF306B-E72F-4048-BA75-3562EC407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408C7-6A37-47A3-9FD4-AA32AA6DBD31}" type="datetimeFigureOut">
              <a:rPr lang="de-DE" smtClean="0"/>
              <a:t>10.07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5F4124C-1F84-454B-81CA-9B76CB117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7131E83-87EE-4A17-AB2A-E40A67010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530-2643-4568-8089-08904E70F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2007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E0B41D1-AA79-46C6-96CD-23BED2745A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E1B311D-675C-46F6-8E17-E0E276DA7C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7B3D38F-F4F2-4FA3-AC64-29FF8B75DA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408C7-6A37-47A3-9FD4-AA32AA6DBD31}" type="datetimeFigureOut">
              <a:rPr lang="de-DE" smtClean="0"/>
              <a:t>10.07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BDF46ED-4F6C-404B-A33E-C29FF4983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5C4C0CF-953D-46A8-9674-0CEF1D63F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530-2643-4568-8089-08904E70F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72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3E59969-F597-4862-929B-6BF286D241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4272DA7-1CA8-400B-B961-81BC40D58D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0C8BDB5-070B-431D-AF5D-53702F35F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408C7-6A37-47A3-9FD4-AA32AA6DBD31}" type="datetimeFigureOut">
              <a:rPr lang="de-DE" smtClean="0"/>
              <a:t>10.07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6FA4DA4-8B1A-4085-9416-67A336A1C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DEA57E5-BB72-409A-A404-FE591E44D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530-2643-4568-8089-08904E70F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9850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C040868-6691-4301-8671-F332EB1AC2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9D56FA4-1675-4F03-B485-C34340F531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67F974F-9647-4C69-A8B4-35DDD0C84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408C7-6A37-47A3-9FD4-AA32AA6DBD31}" type="datetimeFigureOut">
              <a:rPr lang="de-DE" smtClean="0"/>
              <a:t>10.07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96D64F1-C2DC-41A0-B75E-32A0D16953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0512914-A53D-4F03-AD4C-AF85FB64B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530-2643-4568-8089-08904E70F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6970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5467888-81C2-4423-954C-95E250F7CE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9041357-8A97-4EFC-8554-0FB7A8B2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63BBB98-8C0F-443E-815C-4A0FBA2DC7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90D17A7-2423-471E-AFFA-0DE89D87AC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408C7-6A37-47A3-9FD4-AA32AA6DBD31}" type="datetimeFigureOut">
              <a:rPr lang="de-DE" smtClean="0"/>
              <a:t>10.07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FDFC125-D95C-4287-9DCF-A3FB9B81EF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D76FF6A-8325-4C88-AF2C-46368C807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530-2643-4568-8089-08904E70F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3844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FC92405-A893-4F60-B5CA-AD73D02140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426F43F-87EB-401E-9D4E-59FD07C252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1244964-0D17-4A37-A22A-CBADA530C7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970B1F6-22A2-4D43-9C9D-72795DF571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D8125224-66E4-4BF3-9AA9-8895A791D4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04E82083-D38C-4C06-9131-ADC7F23AF7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408C7-6A37-47A3-9FD4-AA32AA6DBD31}" type="datetimeFigureOut">
              <a:rPr lang="de-DE" smtClean="0"/>
              <a:t>10.07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5FD3EF9-DED3-4516-9A04-86BEB1A0F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7A5E19A4-263C-4C65-985A-A34D92E86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530-2643-4568-8089-08904E70F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6895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A83B958-6B23-4493-8D20-06BD331BFC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E547C6AF-D646-4731-B0F7-390E03D26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408C7-6A37-47A3-9FD4-AA32AA6DBD31}" type="datetimeFigureOut">
              <a:rPr lang="de-DE" smtClean="0"/>
              <a:t>10.07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F5BF5C3-B9C1-4674-B9F1-EC9DE59D7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C704A32E-965D-48E8-BBEA-44F06583E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530-2643-4568-8089-08904E70F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2377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7B04F2F6-9B5D-4BE0-BC31-8EBEDA96E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408C7-6A37-47A3-9FD4-AA32AA6DBD31}" type="datetimeFigureOut">
              <a:rPr lang="de-DE" smtClean="0"/>
              <a:t>10.07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ABCC10F0-CD07-4B70-8FE4-4DFC8F0C3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E73141E5-7162-4CC5-85FA-73CE4586F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530-2643-4568-8089-08904E70F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7762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E9CA6AC-1586-4E38-B69B-240BB85E35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D35876A-E06F-4264-BA93-208BFB5C2B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B4EF8FA-382A-465C-9662-BCEF29B74D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10B7F82-EBCE-4B0D-A902-D107DBF69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408C7-6A37-47A3-9FD4-AA32AA6DBD31}" type="datetimeFigureOut">
              <a:rPr lang="de-DE" smtClean="0"/>
              <a:t>10.07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415DF32-4260-4C6C-8A32-9104CDA38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251829C-0882-4B2D-9799-C076668C8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530-2643-4568-8089-08904E70F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2244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283BCEE-BA90-4D78-BFCA-A5B92CB345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C4195EC7-EA6E-4B12-B86C-A66FC6BFC4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299DE13-C3A5-4BA3-A96D-BCA0709BA9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7344E6F-FC9F-4C06-960C-006780AFC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408C7-6A37-47A3-9FD4-AA32AA6DBD31}" type="datetimeFigureOut">
              <a:rPr lang="de-DE" smtClean="0"/>
              <a:t>10.07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0FF3A64-8F09-4A95-8D61-9CE615E1B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8C6FE2F-90B4-408A-B98A-0BAC357E6F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530-2643-4568-8089-08904E70F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6611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8D3AE0FA-0FBF-45A7-8CD5-D91B2B3BF0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BD647D8-D0A9-4C68-B13D-9EB116FA37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22B8C22-F636-4185-A8F0-F84ECF9E4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4408C7-6A37-47A3-9FD4-AA32AA6DBD31}" type="datetimeFigureOut">
              <a:rPr lang="de-DE" smtClean="0"/>
              <a:t>10.07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DA6A0A1-593A-4F95-BB98-EE2D8FBED1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059255D-5BF4-4AB3-B3CC-03DE5ECB7E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4B1530-2643-4568-8089-08904E70F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6322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F9DC7F46-5DFB-4409-AF01-4791C25D2FF1}"/>
              </a:ext>
            </a:extLst>
          </p:cNvPr>
          <p:cNvSpPr txBox="1"/>
          <p:nvPr/>
        </p:nvSpPr>
        <p:spPr>
          <a:xfrm>
            <a:off x="2738436" y="6210300"/>
            <a:ext cx="67151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ideo S1: Perforation of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issachatina fulic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hell above the heart. </a:t>
            </a:r>
            <a:endParaRPr lang="de-DE" dirty="0"/>
          </a:p>
        </p:txBody>
      </p:sp>
      <p:pic>
        <p:nvPicPr>
          <p:cNvPr id="6" name="Video Bohrer">
            <a:hlinkClick r:id="" action="ppaction://media"/>
            <a:extLst>
              <a:ext uri="{FF2B5EF4-FFF2-40B4-BE49-F238E27FC236}">
                <a16:creationId xmlns:a16="http://schemas.microsoft.com/office/drawing/2014/main" id="{036E15F2-9E13-455E-8DF1-CADF468816C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527759" y="282059"/>
            <a:ext cx="3136481" cy="57013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2695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35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9F65D90C-D162-4DF7-83F7-9C46D41BC11D}"/>
              </a:ext>
            </a:extLst>
          </p:cNvPr>
          <p:cNvSpPr txBox="1"/>
          <p:nvPr/>
        </p:nvSpPr>
        <p:spPr>
          <a:xfrm>
            <a:off x="3028948" y="5468034"/>
            <a:ext cx="737235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ideo S2: Cardiac puncture and haemolymph extraction from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issachatina fulic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endParaRPr lang="de-DE" dirty="0"/>
          </a:p>
        </p:txBody>
      </p:sp>
      <p:pic>
        <p:nvPicPr>
          <p:cNvPr id="7" name="HL Ex">
            <a:hlinkClick r:id="" action="ppaction://media"/>
            <a:extLst>
              <a:ext uri="{FF2B5EF4-FFF2-40B4-BE49-F238E27FC236}">
                <a16:creationId xmlns:a16="http://schemas.microsoft.com/office/drawing/2014/main" id="{A2A84058-212A-4B82-A4D2-E403532F775A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171474" y="911225"/>
            <a:ext cx="7849051" cy="431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951924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2328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C9DAC521-AE5A-4CF3-AE3E-FD162F9DCECD}"/>
              </a:ext>
            </a:extLst>
          </p:cNvPr>
          <p:cNvSpPr txBox="1"/>
          <p:nvPr/>
        </p:nvSpPr>
        <p:spPr>
          <a:xfrm>
            <a:off x="4000500" y="6225659"/>
            <a:ext cx="46005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: Gating strategy and histograms.</a:t>
            </a:r>
            <a:endParaRPr lang="de-DE" dirty="0"/>
          </a:p>
        </p:txBody>
      </p:sp>
      <p:pic>
        <p:nvPicPr>
          <p:cNvPr id="4" name="Picture 6">
            <a:extLst>
              <a:ext uri="{FF2B5EF4-FFF2-40B4-BE49-F238E27FC236}">
                <a16:creationId xmlns:a16="http://schemas.microsoft.com/office/drawing/2014/main" id="{565DA83B-599B-4F1B-A65E-DD2C84E0F9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64056"/>
            <a:ext cx="12192000" cy="53298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91719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63E584CA-045F-7E08-A105-81FCFF4F8DCA}"/>
              </a:ext>
            </a:extLst>
          </p:cNvPr>
          <p:cNvSpPr txBox="1"/>
          <p:nvPr/>
        </p:nvSpPr>
        <p:spPr>
          <a:xfrm>
            <a:off x="3829696" y="5331761"/>
            <a:ext cx="520549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1. Exemplary haemocyte counts in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issachatina fulic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endParaRPr lang="de-DE" i="1" dirty="0"/>
          </a:p>
        </p:txBody>
      </p:sp>
      <p:graphicFrame>
        <p:nvGraphicFramePr>
          <p:cNvPr id="5" name="Tabelle 4">
            <a:extLst>
              <a:ext uri="{FF2B5EF4-FFF2-40B4-BE49-F238E27FC236}">
                <a16:creationId xmlns:a16="http://schemas.microsoft.com/office/drawing/2014/main" id="{A01559CE-B508-4931-45F1-9EE34164E46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445046"/>
              </p:ext>
            </p:extLst>
          </p:nvPr>
        </p:nvGraphicFramePr>
        <p:xfrm>
          <a:off x="4212148" y="1951781"/>
          <a:ext cx="3767704" cy="29260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89011">
                  <a:extLst>
                    <a:ext uri="{9D8B030D-6E8A-4147-A177-3AD203B41FA5}">
                      <a16:colId xmlns:a16="http://schemas.microsoft.com/office/drawing/2014/main" val="3031465137"/>
                    </a:ext>
                  </a:extLst>
                </a:gridCol>
                <a:gridCol w="2578693">
                  <a:extLst>
                    <a:ext uri="{9D8B030D-6E8A-4147-A177-3AD203B41FA5}">
                      <a16:colId xmlns:a16="http://schemas.microsoft.com/office/drawing/2014/main" val="711431433"/>
                    </a:ext>
                  </a:extLst>
                </a:gridCol>
              </a:tblGrid>
              <a:tr h="364500">
                <a:tc>
                  <a:txBody>
                    <a:bodyPr/>
                    <a:lstStyle/>
                    <a:p>
                      <a:r>
                        <a:rPr lang="de-DE" dirty="0" err="1"/>
                        <a:t>Snail</a:t>
                      </a:r>
                      <a:r>
                        <a:rPr lang="de-DE" dirty="0"/>
                        <a:t> I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Number </a:t>
                      </a:r>
                      <a:r>
                        <a:rPr lang="de-DE" dirty="0" err="1"/>
                        <a:t>of</a:t>
                      </a:r>
                      <a:r>
                        <a:rPr lang="de-DE" dirty="0"/>
                        <a:t> </a:t>
                      </a:r>
                      <a:r>
                        <a:rPr lang="de-DE" dirty="0" err="1"/>
                        <a:t>cells</a:t>
                      </a:r>
                      <a:r>
                        <a:rPr lang="de-DE" dirty="0"/>
                        <a:t> per m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0595355"/>
                  </a:ext>
                </a:extLst>
              </a:tr>
              <a:tr h="364500">
                <a:tc rowSpan="2">
                  <a:txBody>
                    <a:bodyPr/>
                    <a:lstStyle/>
                    <a:p>
                      <a:r>
                        <a:rPr lang="de-DE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697,9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55648459"/>
                  </a:ext>
                </a:extLst>
              </a:tr>
              <a:tr h="364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240,0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05566792"/>
                  </a:ext>
                </a:extLst>
              </a:tr>
              <a:tr h="364500">
                <a:tc rowSpan="3">
                  <a:txBody>
                    <a:bodyPr/>
                    <a:lstStyle/>
                    <a:p>
                      <a:r>
                        <a:rPr lang="de-DE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82,5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2749615"/>
                  </a:ext>
                </a:extLst>
              </a:tr>
              <a:tr h="364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18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77,5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7554754"/>
                  </a:ext>
                </a:extLst>
              </a:tr>
              <a:tr h="364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475,0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3247954"/>
                  </a:ext>
                </a:extLst>
              </a:tr>
              <a:tr h="364500">
                <a:tc>
                  <a:txBody>
                    <a:bodyPr/>
                    <a:lstStyle/>
                    <a:p>
                      <a:r>
                        <a:rPr lang="de-DE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800,0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01265893"/>
                  </a:ext>
                </a:extLst>
              </a:tr>
              <a:tr h="364500">
                <a:tc>
                  <a:txBody>
                    <a:bodyPr/>
                    <a:lstStyle/>
                    <a:p>
                      <a:r>
                        <a:rPr lang="de-DE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835,0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83071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459510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Breitbild</PresentationFormat>
  <Paragraphs>17</Paragraphs>
  <Slides>4</Slides>
  <Notes>0</Notes>
  <HiddenSlides>0</HiddenSlides>
  <MMClips>2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lena Dusch</dc:creator>
  <cp:lastModifiedBy>Alena Dusch</cp:lastModifiedBy>
  <cp:revision>2</cp:revision>
  <dcterms:created xsi:type="dcterms:W3CDTF">2026-05-31T09:46:26Z</dcterms:created>
  <dcterms:modified xsi:type="dcterms:W3CDTF">2026-07-10T20:20:23Z</dcterms:modified>
</cp:coreProperties>
</file>